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60" r:id="rId3"/>
    <p:sldId id="258" r:id="rId4"/>
    <p:sldId id="259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rima Yoshimi" initials="AY" lastIdx="1" clrIdx="0">
    <p:extLst>
      <p:ext uri="{19B8F6BF-5375-455C-9EA6-DF929625EA0E}">
        <p15:presenceInfo xmlns:p15="http://schemas.microsoft.com/office/powerpoint/2012/main" userId="f2dc9f10a86414e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99"/>
    <a:srgbClr val="00CC00"/>
    <a:srgbClr val="4A7E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3156" y="432"/>
      </p:cViewPr>
      <p:guideLst>
        <p:guide orient="horz" pos="244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rigai\Desktop\Harigai\RealTime-PCR\20150227\20150227_RT-PCR&#12487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rigai\Desktop\Harigai\RealTime-PCR\20150227\20150227_RT-PCR&#12487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6350"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F81BD"/>
              </a:solidFill>
              <a:ln w="63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BBD-419E-8516-5454EF39C186}"/>
              </c:ext>
            </c:extLst>
          </c:dPt>
          <c:dPt>
            <c:idx val="1"/>
            <c:invertIfNegative val="0"/>
            <c:bubble3D val="0"/>
            <c:spPr>
              <a:solidFill>
                <a:srgbClr val="E46C0A"/>
              </a:solidFill>
              <a:ln w="63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BBD-419E-8516-5454EF39C186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F$6:$F$7</c:f>
                <c:numCache>
                  <c:formatCode>General</c:formatCode>
                  <c:ptCount val="2"/>
                  <c:pt idx="0">
                    <c:v>1.05277E-3</c:v>
                  </c:pt>
                  <c:pt idx="1">
                    <c:v>1.4418040000000001E-3</c:v>
                  </c:pt>
                </c:numCache>
              </c:numRef>
            </c:plus>
            <c:minus>
              <c:numRef>
                <c:f>Sheet1!$E$6:$E$7</c:f>
                <c:numCache>
                  <c:formatCode>General</c:formatCode>
                  <c:ptCount val="2"/>
                  <c:pt idx="0">
                    <c:v>8.5158130000000001E-4</c:v>
                  </c:pt>
                  <c:pt idx="1">
                    <c:v>1.04849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6:$C$7</c:f>
              <c:strCache>
                <c:ptCount val="2"/>
                <c:pt idx="0">
                  <c:v>sNF96.2-GFP</c:v>
                </c:pt>
                <c:pt idx="1">
                  <c:v>A-1</c:v>
                </c:pt>
              </c:strCache>
            </c:strRef>
          </c:cat>
          <c:val>
            <c:numRef>
              <c:f>Sheet1!$D$6:$D$7</c:f>
              <c:numCache>
                <c:formatCode>0.0E+00</c:formatCode>
                <c:ptCount val="2"/>
                <c:pt idx="0">
                  <c:v>4.4561069999999999E-3</c:v>
                </c:pt>
                <c:pt idx="1">
                  <c:v>3.843582999999999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BBD-419E-8516-5454EF39C1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7"/>
        <c:overlap val="7"/>
        <c:axId val="2106776576"/>
        <c:axId val="2106779296"/>
      </c:barChart>
      <c:catAx>
        <c:axId val="2106776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6779296"/>
        <c:crossesAt val="1.0000000000000004E-6"/>
        <c:auto val="1"/>
        <c:lblAlgn val="ctr"/>
        <c:lblOffset val="100"/>
        <c:noMultiLvlLbl val="0"/>
      </c:catAx>
      <c:valAx>
        <c:axId val="2106779296"/>
        <c:scaling>
          <c:logBase val="10"/>
          <c:orientation val="minMax"/>
          <c:max val="0.1"/>
          <c:min val="1.0000000000000004E-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1" i="1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600" b="1" i="1" dirty="0">
                    <a:solidFill>
                      <a:schemeClr val="tx1"/>
                    </a:solidFill>
                  </a:rPr>
                  <a:t>BRAP/GAPDH</a:t>
                </a:r>
                <a:r>
                  <a:rPr lang="ja-JP" altLang="en-US" sz="1600" b="1" i="1" baseline="0" dirty="0">
                    <a:solidFill>
                      <a:schemeClr val="tx1"/>
                    </a:solidFill>
                  </a:rPr>
                  <a:t> </a:t>
                </a:r>
                <a:r>
                  <a:rPr lang="ja-JP" altLang="en-US" sz="1600" b="1" i="0" dirty="0" err="1">
                    <a:solidFill>
                      <a:schemeClr val="tx1"/>
                    </a:solidFill>
                  </a:rPr>
                  <a:t>ｍ</a:t>
                </a:r>
                <a:r>
                  <a:rPr lang="en-US" altLang="ja-JP" sz="1600" b="1" i="0" dirty="0">
                    <a:solidFill>
                      <a:schemeClr val="tx1"/>
                    </a:solidFill>
                  </a:rPr>
                  <a:t>RNA ratio</a:t>
                </a:r>
                <a:endParaRPr lang="ja-JP" altLang="en-US" sz="1600" b="1" i="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1" i="1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6776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F31-4D29-A4DE-EBFD1781943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F$12:$F$13</c:f>
                <c:numCache>
                  <c:formatCode>General</c:formatCode>
                  <c:ptCount val="2"/>
                  <c:pt idx="0">
                    <c:v>7.2185369999999997E-4</c:v>
                  </c:pt>
                  <c:pt idx="1">
                    <c:v>2.1757690000000001E-3</c:v>
                  </c:pt>
                </c:numCache>
              </c:numRef>
            </c:plus>
            <c:minus>
              <c:numRef>
                <c:f>Sheet1!$E$12:$E$13</c:f>
                <c:numCache>
                  <c:formatCode>General</c:formatCode>
                  <c:ptCount val="2"/>
                  <c:pt idx="0">
                    <c:v>6.2261309999999998E-4</c:v>
                  </c:pt>
                  <c:pt idx="1">
                    <c:v>1.21954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C$12:$C$13</c:f>
              <c:strCache>
                <c:ptCount val="2"/>
                <c:pt idx="0">
                  <c:v>sNF96.2-GFP</c:v>
                </c:pt>
                <c:pt idx="1">
                  <c:v>A-1</c:v>
                </c:pt>
              </c:strCache>
            </c:strRef>
          </c:cat>
          <c:val>
            <c:numRef>
              <c:f>Sheet1!$D$12:$D$13</c:f>
              <c:numCache>
                <c:formatCode>0.0E+00</c:formatCode>
                <c:ptCount val="2"/>
                <c:pt idx="0">
                  <c:v>4.5287670000000004E-3</c:v>
                </c:pt>
                <c:pt idx="1">
                  <c:v>2.77493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F31-4D29-A4DE-EBFD178194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7"/>
        <c:overlap val="7"/>
        <c:axId val="2106771680"/>
        <c:axId val="2106772224"/>
      </c:barChart>
      <c:catAx>
        <c:axId val="2106771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6772224"/>
        <c:crossesAt val="1.0000000000000004E-6"/>
        <c:auto val="1"/>
        <c:lblAlgn val="ctr"/>
        <c:lblOffset val="100"/>
        <c:noMultiLvlLbl val="0"/>
      </c:catAx>
      <c:valAx>
        <c:axId val="2106772224"/>
        <c:scaling>
          <c:logBase val="10"/>
          <c:orientation val="minMax"/>
          <c:max val="0.1"/>
          <c:min val="1.0000000000000004E-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600" b="1" i="1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600" b="1" i="1" dirty="0">
                    <a:solidFill>
                      <a:schemeClr val="tx1"/>
                    </a:solidFill>
                  </a:rPr>
                  <a:t>PTPN11/GAPDH </a:t>
                </a:r>
                <a:r>
                  <a:rPr lang="ja-JP" altLang="ja-JP" sz="1600" b="1" i="0" u="none" strike="noStrike" baseline="0" dirty="0" err="1">
                    <a:solidFill>
                      <a:schemeClr val="tx1"/>
                    </a:solidFill>
                    <a:effectLst/>
                  </a:rPr>
                  <a:t>ｍ</a:t>
                </a:r>
                <a:r>
                  <a:rPr lang="en-US" altLang="ja-JP" sz="1600" b="1" i="0" u="none" strike="noStrike" baseline="0" dirty="0">
                    <a:solidFill>
                      <a:schemeClr val="tx1"/>
                    </a:solidFill>
                    <a:effectLst/>
                  </a:rPr>
                  <a:t>RNA ratio</a:t>
                </a:r>
                <a:endParaRPr lang="ja-JP" altLang="en-US" sz="1600" b="1" i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600" b="1" i="1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6771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032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255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431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858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1149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359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9857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931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5202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0077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6540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59310-D83B-4D96-8BF6-80BD9E0DDD9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CCA21-F4A8-48F0-B9C5-8CE1E7E73D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4037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コンテンツ プレースホルダー 3">
            <a:extLst>
              <a:ext uri="{FF2B5EF4-FFF2-40B4-BE49-F238E27FC236}">
                <a16:creationId xmlns:a16="http://schemas.microsoft.com/office/drawing/2014/main" id="{EC12AB4B-3EBB-4744-B2C4-6A7D91D5EC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0901964"/>
              </p:ext>
            </p:extLst>
          </p:nvPr>
        </p:nvGraphicFramePr>
        <p:xfrm>
          <a:off x="180022" y="1221582"/>
          <a:ext cx="6512960" cy="450056"/>
        </p:xfrm>
        <a:graphic>
          <a:graphicData uri="http://schemas.openxmlformats.org/drawingml/2006/table">
            <a:tbl>
              <a:tblPr firstRow="1" bandRow="1"/>
              <a:tblGrid>
                <a:gridCol w="8141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3S1358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TH0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21S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18S5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 err="1"/>
                        <a:t>Penta</a:t>
                      </a:r>
                      <a:r>
                        <a:rPr kumimoji="1" lang="en-US" altLang="ja-JP" sz="1100" dirty="0"/>
                        <a:t> </a:t>
                      </a:r>
                      <a:r>
                        <a:rPr kumimoji="1" lang="en-US" altLang="ja-JP" sz="1100" baseline="0" dirty="0"/>
                        <a:t> E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5S818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13S317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7S820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6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6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30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6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5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0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0,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9" name="コンテンツ プレースホルダー 3">
            <a:extLst>
              <a:ext uri="{FF2B5EF4-FFF2-40B4-BE49-F238E27FC236}">
                <a16:creationId xmlns:a16="http://schemas.microsoft.com/office/drawing/2014/main" id="{45187B3C-A299-44D8-BAAF-1395A4436A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3177792"/>
              </p:ext>
            </p:extLst>
          </p:nvPr>
        </p:nvGraphicFramePr>
        <p:xfrm>
          <a:off x="177123" y="1777731"/>
          <a:ext cx="6512960" cy="450056"/>
        </p:xfrm>
        <a:graphic>
          <a:graphicData uri="http://schemas.openxmlformats.org/drawingml/2006/table">
            <a:tbl>
              <a:tblPr firstRow="1" bandRow="1"/>
              <a:tblGrid>
                <a:gridCol w="8141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16S539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CSF1PO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 err="1"/>
                        <a:t>Penta</a:t>
                      </a:r>
                      <a:r>
                        <a:rPr kumimoji="1" lang="en-US" altLang="ja-JP" sz="1100" dirty="0"/>
                        <a:t>  D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AM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 err="1"/>
                        <a:t>vWA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8S1179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TPOX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FGA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2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4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X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7,19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3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22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F81BD">
                        <a:tint val="4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0" name="コンテンツ プレースホルダー 3">
            <a:extLst>
              <a:ext uri="{FF2B5EF4-FFF2-40B4-BE49-F238E27FC236}">
                <a16:creationId xmlns:a16="http://schemas.microsoft.com/office/drawing/2014/main" id="{9D0A0942-CDB1-4AB7-B5BD-D0F59315A4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6867913"/>
              </p:ext>
            </p:extLst>
          </p:nvPr>
        </p:nvGraphicFramePr>
        <p:xfrm>
          <a:off x="188740" y="2748602"/>
          <a:ext cx="6512960" cy="450056"/>
        </p:xfrm>
        <a:graphic>
          <a:graphicData uri="http://schemas.openxmlformats.org/drawingml/2006/table">
            <a:tbl>
              <a:tblPr firstRow="1" bandRow="1"/>
              <a:tblGrid>
                <a:gridCol w="8141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3S1358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TH0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21S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18S5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 err="1"/>
                        <a:t>Penta</a:t>
                      </a:r>
                      <a:r>
                        <a:rPr kumimoji="1" lang="en-US" altLang="ja-JP" sz="1100" dirty="0"/>
                        <a:t> </a:t>
                      </a:r>
                      <a:r>
                        <a:rPr kumimoji="1" lang="en-US" altLang="ja-JP" sz="1100" baseline="0" dirty="0"/>
                        <a:t> E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5S818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13S317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7S820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6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6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30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6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5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0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0,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1" name="コンテンツ プレースホルダー 3">
            <a:extLst>
              <a:ext uri="{FF2B5EF4-FFF2-40B4-BE49-F238E27FC236}">
                <a16:creationId xmlns:a16="http://schemas.microsoft.com/office/drawing/2014/main" id="{502C3774-B0D9-4951-AB1A-59EA700834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9741383"/>
              </p:ext>
            </p:extLst>
          </p:nvPr>
        </p:nvGraphicFramePr>
        <p:xfrm>
          <a:off x="185841" y="3304752"/>
          <a:ext cx="6512960" cy="450056"/>
        </p:xfrm>
        <a:graphic>
          <a:graphicData uri="http://schemas.openxmlformats.org/drawingml/2006/table">
            <a:tbl>
              <a:tblPr firstRow="1" bandRow="1"/>
              <a:tblGrid>
                <a:gridCol w="8141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1412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16S539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CSF1PO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 err="1"/>
                        <a:t>Penta</a:t>
                      </a:r>
                      <a:r>
                        <a:rPr kumimoji="1" lang="en-US" altLang="ja-JP" sz="1100" dirty="0"/>
                        <a:t>  D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AM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 err="1"/>
                        <a:t>vWA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D8S1179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TPOX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FGA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79646">
                        <a:lumMod val="75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028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2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4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X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7,19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3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11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100" dirty="0"/>
                        <a:t>22</a:t>
                      </a:r>
                      <a:endParaRPr kumimoji="1" lang="ja-JP" altLang="en-US" sz="1100" dirty="0"/>
                    </a:p>
                  </a:txBody>
                  <a:tcPr marL="51435" marR="51435" marT="25717" marB="25717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DF9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B71C59-1FBB-4211-A7D5-18389E5D6B18}"/>
              </a:ext>
            </a:extLst>
          </p:cNvPr>
          <p:cNvSpPr txBox="1"/>
          <p:nvPr/>
        </p:nvSpPr>
        <p:spPr>
          <a:xfrm>
            <a:off x="177123" y="940995"/>
            <a:ext cx="109356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34"/>
            <a:r>
              <a:rPr kumimoji="1" lang="en-US" altLang="ja-JP" sz="1350" b="1" dirty="0">
                <a:solidFill>
                  <a:prstClr val="black"/>
                </a:solidFill>
                <a:ea typeface="ＭＳ Ｐゴシック" panose="020B0600070205080204" pitchFamily="50" charset="-128"/>
              </a:rPr>
              <a:t>sNF96.2-GFP</a:t>
            </a:r>
            <a:endParaRPr kumimoji="1" lang="ja-JP" altLang="en-US" sz="1350" b="1" dirty="0">
              <a:solidFill>
                <a:prstClr val="black"/>
              </a:solidFill>
              <a:ea typeface="ＭＳ Ｐゴシック" panose="020B0600070205080204" pitchFamily="50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B89E1A4-ECD5-4F7F-9963-52D90F365E86}"/>
              </a:ext>
            </a:extLst>
          </p:cNvPr>
          <p:cNvSpPr txBox="1"/>
          <p:nvPr/>
        </p:nvSpPr>
        <p:spPr>
          <a:xfrm>
            <a:off x="156303" y="2488916"/>
            <a:ext cx="42992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57134"/>
            <a:r>
              <a:rPr kumimoji="1" lang="en-US" altLang="ja-JP" sz="1350" b="1" dirty="0">
                <a:solidFill>
                  <a:prstClr val="black"/>
                </a:solidFill>
                <a:ea typeface="ＭＳ Ｐゴシック" panose="020B0600070205080204" pitchFamily="50" charset="-128"/>
              </a:rPr>
              <a:t>A-1</a:t>
            </a:r>
            <a:endParaRPr kumimoji="1" lang="ja-JP" altLang="en-US" sz="1350" b="1" dirty="0">
              <a:solidFill>
                <a:prstClr val="black"/>
              </a:solidFill>
              <a:ea typeface="ＭＳ Ｐゴシック" panose="020B0600070205080204" pitchFamily="50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A7C0306-5D88-414A-A8A6-0E67171575F9}"/>
              </a:ext>
            </a:extLst>
          </p:cNvPr>
          <p:cNvSpPr txBox="1"/>
          <p:nvPr/>
        </p:nvSpPr>
        <p:spPr>
          <a:xfrm>
            <a:off x="419631" y="4036837"/>
            <a:ext cx="621682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6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. </a:t>
            </a:r>
            <a:r>
              <a:rPr lang="en-US" sz="1600" b="0" i="0" u="none" strike="noStrike" baseline="0" dirty="0">
                <a:latin typeface="URWPalladioL-Roma"/>
              </a:rPr>
              <a:t>Confirmation of the identity of A-1 cells with parental sNF96.2-GFP cells via STR analysis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5729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28DA74D-BFE0-4F14-9FCE-8F39D26072FB}"/>
              </a:ext>
            </a:extLst>
          </p:cNvPr>
          <p:cNvSpPr txBox="1"/>
          <p:nvPr/>
        </p:nvSpPr>
        <p:spPr>
          <a:xfrm>
            <a:off x="416421" y="7756864"/>
            <a:ext cx="5951328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. </a:t>
            </a:r>
            <a:r>
              <a:rPr lang="en-US" sz="1400" b="0" i="0" u="none" strike="noStrike" baseline="0" dirty="0">
                <a:latin typeface="URWPalladioL-Roma"/>
              </a:rPr>
              <a:t>Experimental scheme for genome DNA analysis of tumor-derived cells. sNF96.2-GFP cells were injected below the renal capsule of immunodeficient mice, and tumor-derived cells were established from each mouse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48D90C4-EDA2-48C1-8D61-87689DD244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3245" y="170334"/>
            <a:ext cx="3933856" cy="4633020"/>
          </a:xfrm>
          <a:prstGeom prst="rect">
            <a:avLst/>
          </a:prstGeom>
        </p:spPr>
      </p:pic>
      <p:pic>
        <p:nvPicPr>
          <p:cNvPr id="577" name="図 576">
            <a:extLst>
              <a:ext uri="{FF2B5EF4-FFF2-40B4-BE49-F238E27FC236}">
                <a16:creationId xmlns:a16="http://schemas.microsoft.com/office/drawing/2014/main" id="{BD8C0841-C0CE-4D8E-855C-C939895A72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9325" y="4900478"/>
            <a:ext cx="4255248" cy="27592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2754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A7C0306-5D88-414A-A8A6-0E67171575F9}"/>
              </a:ext>
            </a:extLst>
          </p:cNvPr>
          <p:cNvSpPr txBox="1"/>
          <p:nvPr/>
        </p:nvSpPr>
        <p:spPr>
          <a:xfrm>
            <a:off x="624262" y="4371945"/>
            <a:ext cx="554518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. </a:t>
            </a:r>
            <a:r>
              <a:rPr lang="en-US" sz="18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dentification of 42 genes commonly harboring mutations in tumor-derived cells (A-1, B-1, C-1, and D-1 cells). 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D102F4A-5513-45BD-8521-E8EF617E3E87}"/>
              </a:ext>
            </a:extLst>
          </p:cNvPr>
          <p:cNvSpPr txBox="1"/>
          <p:nvPr/>
        </p:nvSpPr>
        <p:spPr>
          <a:xfrm>
            <a:off x="624262" y="1072899"/>
            <a:ext cx="5639222" cy="25545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2000" dirty="0"/>
              <a:t>NMUR2, MYH9, KANSL1L, IMPG2, DNHD1, AMER1, MIR548I4, NOS3, ZNF718, SCHIP1, ALKBH2, PCNT, PRR5-ARHGAP8, ZNF595, ARHGAP8, MXRA8, SQRDL, DENND4C, PTPN11, SLC5A11, CNTNAP2, TMEM132A, TDRD6, PTK7, ATG9B, RIN3, ZSCAN25, BRAP, TMEM109, SCNN1B, SVEP1, DCP2, COL6A6, WIPF1, SYNE1, FADS2, BCAT1, C3, USP30, RPGRIP1, KIAA1024, IQCJ-SCHIP1</a:t>
            </a:r>
          </a:p>
        </p:txBody>
      </p:sp>
    </p:spTree>
    <p:extLst>
      <p:ext uri="{BB962C8B-B14F-4D97-AF65-F5344CB8AC3E}">
        <p14:creationId xmlns:p14="http://schemas.microsoft.com/office/powerpoint/2010/main" val="27772839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2AE8A32-83C7-4E04-824E-D938E2535A4F}"/>
              </a:ext>
            </a:extLst>
          </p:cNvPr>
          <p:cNvSpPr txBox="1"/>
          <p:nvPr/>
        </p:nvSpPr>
        <p:spPr>
          <a:xfrm>
            <a:off x="10157" y="11617"/>
            <a:ext cx="44435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F9A556-7975-4DF4-8AB2-B243692822DB}"/>
              </a:ext>
            </a:extLst>
          </p:cNvPr>
          <p:cNvSpPr txBox="1"/>
          <p:nvPr/>
        </p:nvSpPr>
        <p:spPr>
          <a:xfrm>
            <a:off x="3415164" y="11617"/>
            <a:ext cx="42511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/>
          <p:cNvGrpSpPr/>
          <p:nvPr/>
        </p:nvGrpSpPr>
        <p:grpSpPr>
          <a:xfrm>
            <a:off x="46486" y="418561"/>
            <a:ext cx="3534914" cy="4516620"/>
            <a:chOff x="46486" y="418561"/>
            <a:chExt cx="3534914" cy="4516620"/>
          </a:xfrm>
        </p:grpSpPr>
        <p:sp>
          <p:nvSpPr>
            <p:cNvPr id="8" name="テキスト ボックス 7"/>
            <p:cNvSpPr txBox="1"/>
            <p:nvPr/>
          </p:nvSpPr>
          <p:spPr>
            <a:xfrm>
              <a:off x="125373" y="418561"/>
              <a:ext cx="6495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BRAP</a:t>
              </a:r>
              <a:endParaRPr kumimoji="1" lang="ja-JP" altLang="en-US" sz="1600" b="1" dirty="0"/>
            </a:p>
          </p:txBody>
        </p:sp>
        <p:sp>
          <p:nvSpPr>
            <p:cNvPr id="9" name="正方形/長方形 8"/>
            <p:cNvSpPr>
              <a:spLocks/>
            </p:cNvSpPr>
            <p:nvPr/>
          </p:nvSpPr>
          <p:spPr>
            <a:xfrm>
              <a:off x="46486" y="757114"/>
              <a:ext cx="3534914" cy="41780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TGAGTGTGTCACTGGTTGTTATCCGATTGGAGCTCGCGGAACACTCGCCTGTCCCCGCCGGCTTCGGCTTCAGCGCCGCGGCCGGG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TGAGTGTGTCACTGGTTGTTATCCGATTGGAGCTCGCGGAACACTCGCCTGTCCCCGCCGGCTTCGGCTTCAGCGCCGCGGCCGGG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TGTCTGATGAGGAGATAAAAAAGACGACACTAGCCTCAGCTGTAGCCTGTTTAGAAGGCAAGTCACCAGGAGAGAAAGTAGCGATTAT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TGTCTGATGAGGAGATAAAAAAGACGACACTAGCCTCAGCTGTAGCCTGTTTAGAAGGCAAGTCACCAGGAGAGAAAGTAGCGATTAT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ATCAGCATCTCGGCCGTCGAGAAATGACAGATGTGATCATTGAGACCATGAAGTCCAACCCAGATGAACTAAAAACTACAGTGGAA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ATCAGCATCTCGGCCGTCGAGAAATGACAGATGTGATCATTGAGACCATGAAGTCCAACCCAGATGAACTAAAAACTACAGTGGAA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GGAAGTCTTCAGAAGCCTCCCCCACTGCGCAAAGAAGTAAAGATCACAGTAAGGAATGCATAAACGCTGCCCCAGATTCTCCGTCCA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GGAAGTCTTCAGAAGCCTCCCCCACTGCGCAAAGAAGTAAAGATCACAGTAAGGAATGCATAAACGCTGCCCCAGATTCTCCGTCCA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AGCTTCCAGACCAGATTTCATTCTTCAGTGGAAATCCATCAGTTGAAATAGTTCATGGTATTATGCACCTATATAAGACAAATAAGA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AGCTTCCAGACCAGATTTCATTCTTCAGTGGAAATCCATCAGTTGAAATAGTTCATGGTATTATGCACCTATATAAGACAAATAAGA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CCTCCTTAAAAGAAGATGTGCGGCGCAGTGCCATGCTGTGTATTCTCACAGTCCCTGCTGCAATGACCAGTCATGACCTTATGAAGTT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CCTCCTTAAAAGAAGATGTGCGGCGCAGTGCCATGCTGTGTATTCTCACAGTCCCTGCTGCAATGACCAGTCATGACCTTATGAAGTT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TTGCCCCATTTAACGAAGTAATTGAACAAATGAAAATTATCAGAGACTCTACTCCCAACCAATATATGGTGCTGATAAAGTTTCGTG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TTGCCCCATTTAACGAAGTAATTGAACAAATGAAAATTATCAGAGACTCTACTCCCAACCAATATATGGTGCTGATAAAGTTTCGTG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AGGCTGATGCGGATAGTTTTTATATGACATGCAATGGCCGCCAGTTCAACTCAATAGAAGATGACGTTTGCCAGCTAGTGTATGTG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AGGCTGATGCGGATAGTTTTTATATGACATGCAATGGCCGCCAGTTCAACTCAATAGAAGATGACGTTTGCCAGCTAGTGTATGTG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GAGCTGAAGTGCTCAAATCTGAAGATGGCGCCAGCCTCCCAGTGATGGACCTGACTGAACTCCCCAAGTGCACGGTGTGTCTGGAGCG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GAGCTGAAGTGCTCAAATCTGAAGATGGCGCCAGCCTCCCAGTGATGGACCTGACTGAACTCCCCAAGTGCACGGTGTGTCTGGAGCG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TGGACGAGTCTGTGAATGGCATCCTCACAACGTTATGTAACCACAGCTTCCACAGCCAGTGTCTACAGCGCTGGGACGATACCACGTG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TGGACGAGTCTGTGAATGGCATCCTCACAACGTTATGTAACCACAGCTTCCACAGCCAGTGTCTACAGCGCTGGGACGATACCACGTG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CTGTTTGCCGGTACTGTCAAACGCCCGAGCCAGTAGAAGAAAATAAGTGTTTTGAGTGTGGTGTTCAGGAAAATCTTTGGATTTGTTT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CTGTTTGCCGGTACTGTCAAACGCCCGAGCCAGTAGAAGAAAATAAGTGTTTTGAGTGTGGTGTTCAGGAAAATCTTTGGATTTGTTT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TATGCGGCCACATAGGATGTGGACGGTATGTCAGTCGACATGCTTATAAGCACTTTGAGGAAACGCAGCACACGTATGCCATGCAGCT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TATGCGGCCACATAGGATGTGGACGGTATGTCAGTCGACATGCTTATAAGCACTTTGAGGAAACGCAGCACACGTATGCCATGCAGCT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CCAACCATCGAGTCTGGGACTATGCTG</a:t>
              </a:r>
              <a:r>
                <a:rPr lang="en-US" altLang="ja-JP" sz="450" b="1" kern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G</a:t>
              </a:r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GATAACTATGTTCATCGACTGGTTGCAAGTAAAACAGATGGAAAAATAGTACAGTAT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CCAACCATCGAGTCTGGGACTATGCTG</a:t>
              </a:r>
              <a:r>
                <a:rPr lang="en-US" altLang="ja-JP" sz="450" b="1" kern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C</a:t>
              </a:r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GATAACTATGTTCATCGACTGGTTGCAAGTAAAACAGATGGAAAAATAGTACAGTAT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TGTGAGGGGGATACTTGCCAGGAAGAGAAAATAGATGCCTTACAGTTAGAGTATTCATATTTACTAACAAGCCAGCTGGAATCTCAGC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TGTGAGGGGGATACTTGCCAGGAAGAGAAAATAGATGCCTTACAGTTAGAGTATTCATATTTACTAACAAGCCAGCTGGAATCTCAGC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TCTACTGGGAAAACAAGATAGTTCGGATAGAGAAGGACACAGCAGAGGAAATTAACAACATGAAGACCAAGTTTAAAGAAACAATTG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TCTACTGGGAAAACAAGATAGTTCGGATAGAGAAGGACACAGCAGAGGAAATTAACAACATGAAGACCAAGTTTAAAGAAACAATTG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AGTGTGATAATCTAGAGCACAAACTAAATGATCTCCTAAAAGAAAAGCAGTCTGTGGAAAGAAAGTGCACTCAGCTAAACACAAAAG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AGTGTGATAATCTAGAGCACAAACTAAATGATCTCCTAAAAGAAAAGCAGTCTGTGGAAAGAAAGTGCACTCAGCTAAACACAAAAG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CCAAACTCACCAACGAGCTCAAAGAGGAGCAGGAAATGAACAAGTGTTTGCGAGCCAACCAAGTCCTCCTGCAGAACAAGCTAAAAG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CCAAACTCACCAACGAGCTCAAAGAGGAGCAGGAAATGAACAAGTGTTTGCGAGCCAACCAAGTCCTCCTGCAGAACAAGCTAAAAG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GGAGAGGGTGCTGAAGGAGACCTGTGACCAAAAAGATCTGCAGATCACCGAGATCCAGGAGCAGCTGCGTGACGTCATGTTCTACC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GGAGAGGGTGCTGAAGGAGACCTGTGACCAAAAAGATCTGCAGATCACCGAGATCCAGGAGCAGCTGCGTGACGTCATGTTCTACC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GACACAGCAGAAGATCAACCATCTGCCTGCCGAGACCCGGCAGGAAATCCAGGAGGGACAGATCAACATCGCCATGGCCTCGGCCTC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GACACAGCAGAAGATCAACCATCTGCCTGCCGAGACCCGGCAGGAAATCCAGGAGGGACAGATCAACATCGCCATGGCCTCGGCCTC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GCCCTGCCTCTTCGGGGGGCAGTGGGAAGTTGCCCTCCAGGAAGGGCCGCAGCAAGAGGGGCAAGT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GCCCTGCCTCTTCGGGGGGCAGTGGGAAGTTGCCCTCCAGGAAGGGCCGCAGCAAGAGGGGCAAGT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角丸四角形 9"/>
            <p:cNvSpPr>
              <a:spLocks/>
            </p:cNvSpPr>
            <p:nvPr/>
          </p:nvSpPr>
          <p:spPr>
            <a:xfrm>
              <a:off x="1254093" y="3264513"/>
              <a:ext cx="36000" cy="144000"/>
            </a:xfrm>
            <a:prstGeom prst="round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/>
            </a:p>
          </p:txBody>
        </p:sp>
      </p:grpSp>
      <p:grpSp>
        <p:nvGrpSpPr>
          <p:cNvPr id="13" name="グループ化 12"/>
          <p:cNvGrpSpPr/>
          <p:nvPr/>
        </p:nvGrpSpPr>
        <p:grpSpPr>
          <a:xfrm>
            <a:off x="3412874" y="418561"/>
            <a:ext cx="3591176" cy="4516620"/>
            <a:chOff x="3412874" y="418561"/>
            <a:chExt cx="3591176" cy="4516620"/>
          </a:xfrm>
        </p:grpSpPr>
        <p:sp>
          <p:nvSpPr>
            <p:cNvPr id="14" name="テキスト ボックス 13"/>
            <p:cNvSpPr txBox="1"/>
            <p:nvPr/>
          </p:nvSpPr>
          <p:spPr>
            <a:xfrm>
              <a:off x="3460009" y="418561"/>
              <a:ext cx="84612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PTPN11</a:t>
              </a:r>
              <a:endParaRPr kumimoji="1" lang="ja-JP" altLang="en-US" sz="1600" b="1" dirty="0"/>
            </a:p>
          </p:txBody>
        </p:sp>
        <p:sp>
          <p:nvSpPr>
            <p:cNvPr id="15" name="正方形/長方形 14"/>
            <p:cNvSpPr/>
            <p:nvPr/>
          </p:nvSpPr>
          <p:spPr>
            <a:xfrm>
              <a:off x="3412874" y="757114"/>
              <a:ext cx="3591176" cy="41780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TGACATCGCGGAGATGGTTTCACCCAAATATCACTGGTGTGGAGGCAGAAAACCTACTGTTGACAAGAGGAGTTGATGGCAGTTTTT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TGACATCGCGGAGATGGTTTCACCCAAATATCACTGGTGTGGAGGCAGAAAACCTACTGTTGACAAGAGGAGTTGATGGCAGTTTTT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CAAGGCCTAGTAAAAGTAACCCTGGAGACTTCACACTTTCCGTTAGAAGAAATGGAGCTGTCACCCACATCAAGATTCAGAACACTGG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CAAGGCCTAGTAAAAGTAACCCTGGAGACTTCACACTTTCCGTTAGAAGAAATGGAGCTGTCACCCACATCAAGATTCAGAACACTGG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TTACTATGACCTGTATGGAGGGGAGAAATTTGCCACTTTGGCTGAGTTGGTCCAGTATTACATGGAACATCACGGGCAATTAAAAG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TTACTATGACCTGTATGGAGGGGAGAAATTTGCCACTTTGGCTGAGTTGGTCCAGTATTACATGGAACATCACGGGCAATTAAAAG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AGAATGGAGATGTCATTGAGCTTAAATATCCTCTGAACTGTGCAGATCCTACCTCTGAAAGGTGGTTTCATGGACATCTCTCTGGGA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AGAATGGAGATGTCATTGAGCTTAAATATCCTCTGAACTGTGCAGATCCTACCTCTGAAAGGTGGTTTCATGGACATCTCTCTGGGA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AGCAGAGAAATTATTAACTGAAAAAGGAAAACATGGTAGTTTTCTTGTACGAGAGAGCCAGAGCCACCCTGGAGATTTTGTTCTTTC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AGCAGAGAAATTATTAACTGAAAAAGGAAAACATGGTAGTTTTCTTGTACGAGAGAGCCAGAGCCACCCTGGAGATTTTGTTCTTTC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TGCGCACTGGTGATGACAAAGGGGAGAGCAATGACGGCAAGTCTAAAGTGACCCATGTTATGATTCGCTGTCAGGAACTGAAATACGA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TGCGCACTGGTGATGACAAAGGGGAGAGCAATGACGGCAAGTCTAAAGTGACCCATGTTATGATTCGCTGTCAGGAACTGAAATACGA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TTGGTGGAGGAGAACGGTTTGATTCTTTGACAGATCTTGTGGAACATTATAAGAAGAATCCTATGGTGGAAACATTGGGTACAGTACT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TTGGTGGAGGAGAACGGTTTGATTCTTTGACAGATCTTGTGGAACATTATAAGAAGAATCCTATGGTGGAAACATTGGGTACAGTACT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AACTCAAGCAGCCCCTTAACACGACTCGTATAAATGCTGCTGAAATAGAAAGCAGAGTTCGAGAACTAAGCAAATTAGCTGAGACCA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AACTCAAGCAGCCCCTTAACACGACTCGTATAAATGCTGCTGAAATAGAAAGCAGAGTTCGAGAACTAAGCAAATTAGCTGAGACCA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TAAAGTCAAACAAGGCTTTTGGGAAGAATTTGAGACACTACAACAACAGGAGTGCAAACTTCTCTACAGCCGAAAAGAGGGTCAAAG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TAAAGTCAAACAAGGCTTTTGGGAAGAATTTGAGACACTACAACAACAGGAGTGCAAACTTCTCTACAGCCGAAAAGAGGGTCAAAG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AAGAAAACAAAAACAAAAATAGATATAAAAACATCCTGCCCTTTGATCATACCAGGGTTGTCCTACACGATGGTGATCCCAATGAGCC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AAGAAAACAAAAACAAAAATAGATATAAAAACATCCTGCCCTTTGATCATACCAGGGTTGTCCTACACGATGGTGATCCCAATGAGCC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TTTCAGATTACATCAATGCAAATATCATCATGCCTGAATTTGAAACCAAGTGCAACAATTCAAAGCCCAAAAAGAGTTACATTGCCA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TTTCAGATTACATCAATGCAAATATCATCATGCCTGAATTTGAAACCAAGTGCAACAATTCAAAGCCCAAAAAGAGTTACATTGCCA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AAGGCTGCCTGCAAAACACGGTGAATGACTTTTGGCGGATGGTGTTCCAAGAAAACTCCCGAGTGATTGTCATGACAACGAAAGAAG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AAGGCTGCCTGCAAAACACGGTGAATGACTTTTGGCGGATGGTGTTCCAAGAAAACTCCCGAGTGATTGTCATGACAACGAAAGAAG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GAGAGGAAAGAGTAAATGTGTCAAATACTGGCCTGATGAGTATGCTCTAAAAGAATATGGCGTCATGCGTGTTAGGAACGTCAAA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GAGAGGAAAGAGTAAATGTGTCAAATACTGGCCTGATGAGTATGCTCTAAAAGAATATGGCGTCATGCGTGTTAGGAACGTCAAAGA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AGCGCCGCTCATGACTATACGCTAAGAGAACTTAAACTTTCAAAGGTTGGACAAGGGAATACGGAGAGAACGGTCTGGCAATACCACTT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AGCGCCGCTCATGACTATACGCTAAGAGAACTTAAACTTTCAAAGGTTGGACAAGGGAATACGGAGAGAACGGTCTGGCAATACCACTTT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CGGACCTGGCCGGACCACGGCGTGCCCAGCGACCCTGGGGGCGTGCTGGACTTCCTGGAGGAGGTGCACCATAAGCAGGAGAGCATCA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CGGACCTGGCCGGACCACGGCGTGCCCAGCGACCCTGGGGGCGTGCTGGACTTCCTGGAGGAGGTGCACCATAAGCAGGAGAGCATCAT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TGCAGGGCCGGTCGTGGTGCACTGCAGTGCTGGAATTGGCCGGACAGGGACGTTCATTGTGATTGATATTCTTATTGACATCATCA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TGCAGGGCCGGTCGTGGTGCACTGCAGTGCTGGAATTGGCCGGACAGGGACGTTCATTGTGATTGATATTCTTATTGACATCATCA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GAAAGGTGTTGACTGCGATATTGACGTTCCCAAAACCATCCAGATGGTGCGGTCTCAGAGGTCAG</a:t>
              </a:r>
              <a:r>
                <a:rPr lang="en-US" altLang="ja-JP" sz="450" b="1" kern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G</a:t>
              </a:r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GATGGTCCAGACAGAAGCAC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GAAAGGTGTTGACTGCGATATTGACGTTCCCAAAACCATCCAGATGGTGCGGTCTCAGAGGTCAG</a:t>
              </a:r>
              <a:r>
                <a:rPr lang="en-US" altLang="ja-JP" sz="450" b="1" kern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T</a:t>
              </a:r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GATGGTCCAGACAGAAGCACAG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TACCGATTTATCTATATGGCGGTCCAGCATTATATTGAAACACTACAGCGCAGGATTGAAGAAGAGCAGAAAAGCAAGAGGAAAGGGCA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TACCGATTTATCTATATGGCGGTCCAGCATTATATTGAAACACTACAGCGCAGGATTGAAGAAGAGCAGAAAAGCAAGAGGAAAGGGCAC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ATATACAAATATTAAGTATTCTCTAGCGGACCAGACGAGTGGAGATCAGAGCCCTCTCCCGCCTTGTACTCCAACGCCACCCTGTG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ATATACAAATATTAAGTATTCTCTAGCGGACCAGACGAGTGGAGATCAGAGCCCTCTCCCGCCTTGTACTCCAACGCCACCCTGTGC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 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P-G GAAATGAGAGAAGACAGTGCTAGAGTCTATGAAAACGTGGGCCTGATGCAACAGCAGAAAAGTTTCAGAT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  <a:p>
              <a:r>
                <a:rPr lang="en-US" altLang="ja-JP" sz="450" b="1" kern="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A-1 GAAATGAGAGAAGACAGTGCTAGAGTCTATGAAAACGTGGGCCTGATGCAACAGCAGAAAAGTTTCAGATGA</a:t>
              </a:r>
              <a:endParaRPr lang="ja-JP" altLang="ja-JP" sz="450" b="1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角丸四角形 15"/>
            <p:cNvSpPr>
              <a:spLocks/>
            </p:cNvSpPr>
            <p:nvPr/>
          </p:nvSpPr>
          <p:spPr>
            <a:xfrm>
              <a:off x="5983573" y="4082393"/>
              <a:ext cx="36000" cy="144000"/>
            </a:xfrm>
            <a:prstGeom prst="round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/>
            </a:p>
          </p:txBody>
        </p:sp>
      </p:grpSp>
    </p:spTree>
    <p:extLst>
      <p:ext uri="{BB962C8B-B14F-4D97-AF65-F5344CB8AC3E}">
        <p14:creationId xmlns:p14="http://schemas.microsoft.com/office/powerpoint/2010/main" val="16608580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5321F61-F99B-A388-935C-3FC053CF5C1D}"/>
              </a:ext>
            </a:extLst>
          </p:cNvPr>
          <p:cNvSpPr txBox="1"/>
          <p:nvPr/>
        </p:nvSpPr>
        <p:spPr>
          <a:xfrm>
            <a:off x="187286" y="5932450"/>
            <a:ext cx="6775373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4. 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ignment of the nucleotide sequences of 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AP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A) and 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TPN11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) for sNF96.2-GFP (P-G) and A-1 cells as performed with </a:t>
            </a:r>
            <a:r>
              <a:rPr lang="en-US" sz="16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lustalW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ase differences are boxed in red) as well as quantitative RT-PCR analysis of 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AP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C) and 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TPN11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D) mRNA abundance in these cells (data are means ± SD from three independent experiments). 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A5A2CF72-FD41-BA8F-881A-019276D8D6FC}"/>
              </a:ext>
            </a:extLst>
          </p:cNvPr>
          <p:cNvSpPr txBox="1"/>
          <p:nvPr/>
        </p:nvSpPr>
        <p:spPr>
          <a:xfrm>
            <a:off x="109309" y="1262250"/>
            <a:ext cx="44435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5">
            <a:extLst>
              <a:ext uri="{FF2B5EF4-FFF2-40B4-BE49-F238E27FC236}">
                <a16:creationId xmlns:a16="http://schemas.microsoft.com/office/drawing/2014/main" id="{1CCAB1D4-9CD5-8E14-856B-32BC78675B60}"/>
              </a:ext>
            </a:extLst>
          </p:cNvPr>
          <p:cNvSpPr txBox="1"/>
          <p:nvPr/>
        </p:nvSpPr>
        <p:spPr>
          <a:xfrm>
            <a:off x="3482147" y="1262249"/>
            <a:ext cx="444352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10">
            <a:extLst>
              <a:ext uri="{FF2B5EF4-FFF2-40B4-BE49-F238E27FC236}">
                <a16:creationId xmlns:a16="http://schemas.microsoft.com/office/drawing/2014/main" id="{B0F7969B-5168-087A-8E4C-570ED22214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2369816"/>
              </p:ext>
            </p:extLst>
          </p:nvPr>
        </p:nvGraphicFramePr>
        <p:xfrm>
          <a:off x="99152" y="1591550"/>
          <a:ext cx="324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11">
            <a:extLst>
              <a:ext uri="{FF2B5EF4-FFF2-40B4-BE49-F238E27FC236}">
                <a16:creationId xmlns:a16="http://schemas.microsoft.com/office/drawing/2014/main" id="{21256EF8-323D-BF9C-C519-93AABEF3D3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5405139"/>
              </p:ext>
            </p:extLst>
          </p:nvPr>
        </p:nvGraphicFramePr>
        <p:xfrm>
          <a:off x="3326959" y="1591550"/>
          <a:ext cx="324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844599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13</TotalTime>
  <Words>515</Words>
  <Application>Microsoft Office PowerPoint</Application>
  <PresentationFormat>全屏显示(4:3)</PresentationFormat>
  <Paragraphs>19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URWPalladioL-Roma</vt:lpstr>
      <vt:lpstr>Arial</vt:lpstr>
      <vt:lpstr>Calibri</vt:lpstr>
      <vt:lpstr>Calibri Light</vt:lpstr>
      <vt:lpstr>Century</vt:lpstr>
      <vt:lpstr>Courier New</vt:lpstr>
      <vt:lpstr>Palatino Linotype</vt:lpstr>
      <vt:lpstr>Office テーマ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rima Yoshimi</dc:creator>
  <cp:lastModifiedBy>MDPI</cp:lastModifiedBy>
  <cp:revision>59</cp:revision>
  <dcterms:created xsi:type="dcterms:W3CDTF">2021-01-22T06:44:34Z</dcterms:created>
  <dcterms:modified xsi:type="dcterms:W3CDTF">2022-05-12T08:26:26Z</dcterms:modified>
</cp:coreProperties>
</file>